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390" y="6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ktangel 2"/>
          <p:cNvSpPr/>
          <p:nvPr/>
        </p:nvSpPr>
        <p:spPr>
          <a:xfrm>
            <a:off x="206438" y="2499465"/>
            <a:ext cx="648482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sz="1200" b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3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ductive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geny virus production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 more than 5 weeks after ANDV-infection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lung tissue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del.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evels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progeny viruses detected in basolateral supernatant over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ime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 mean ± SEM of three independent experiments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each experiment two infected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dels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ere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alyzed. FFU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focus forming units. dpi; days post infection.</a:t>
            </a:r>
            <a:endParaRPr lang="sv-S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3" name="Bildobjekt 1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19" t="5351" r="30610" b="33274"/>
          <a:stretch/>
        </p:blipFill>
        <p:spPr bwMode="auto">
          <a:xfrm>
            <a:off x="457200" y="601348"/>
            <a:ext cx="2418839" cy="16777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57</TotalTime>
  <Words>61</Words>
  <Application>Microsoft Office PowerPoint</Application>
  <PresentationFormat>Bildspel på skärmen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-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ild 1</dc:title>
  <dc:creator>Shawon Gupta</dc:creator>
  <cp:lastModifiedBy>Jonas Klingström</cp:lastModifiedBy>
  <cp:revision>115</cp:revision>
  <cp:lastPrinted>2015-05-20T09:56:58Z</cp:lastPrinted>
  <dcterms:created xsi:type="dcterms:W3CDTF">2012-05-16T12:12:27Z</dcterms:created>
  <dcterms:modified xsi:type="dcterms:W3CDTF">2016-02-12T12:14:48Z</dcterms:modified>
</cp:coreProperties>
</file>